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39"/>
    <p:restoredTop sz="99306" autoAdjust="0"/>
  </p:normalViewPr>
  <p:slideViewPr>
    <p:cSldViewPr snapToGrid="0">
      <p:cViewPr varScale="1">
        <p:scale>
          <a:sx n="146" d="100"/>
          <a:sy n="146" d="100"/>
        </p:scale>
        <p:origin x="169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Volumes/group09/Carrie/Breast%20Cancer%20project/Carrie's%20Data/Anoikis%20assay/anoikis%20via%20CTG%20121117/BC%20anoikis_CTG_121117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Volumes/group09/Carrie/Breast%20Cancer%20project/Carrie's%20Data/CTG/BC%20CTG_121117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Volumes/group09/Carrie/Breast%20Cancer%20project/Carrie's%20Data/CTG/BC%20CTG_121117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Volumes/group09/Carrie/Breast%20Cancer%20project/Carrie's%20Data/Anoikis%20assay/siIKKe%20combin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900" dirty="0"/>
              <a:t>MDA 231</a:t>
            </a:r>
          </a:p>
        </c:rich>
      </c:tx>
      <c:layout>
        <c:manualLayout>
          <c:xMode val="edge"/>
          <c:yMode val="edge"/>
          <c:x val="0.460941307100586"/>
          <c:y val="0.08398745081994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41298601723129"/>
          <c:y val="0.201486114956556"/>
          <c:w val="0.708227938267687"/>
          <c:h val="0.614440727344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siIKKe combined.xlsx]siIKKe'!$N$27</c:f>
              <c:strCache>
                <c:ptCount val="1"/>
                <c:pt idx="0">
                  <c:v>H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siIKKe!$P$28:$P$31</c:f>
                <c:numCache>
                  <c:formatCode>General</c:formatCode>
                  <c:ptCount val="4"/>
                  <c:pt idx="0">
                    <c:v>0.118577299499844</c:v>
                  </c:pt>
                  <c:pt idx="1">
                    <c:v>0.0816723465676937</c:v>
                  </c:pt>
                  <c:pt idx="2">
                    <c:v>0.0900206835237358</c:v>
                  </c:pt>
                  <c:pt idx="3">
                    <c:v>0.0175889285822666</c:v>
                  </c:pt>
                </c:numCache>
              </c:numRef>
            </c:plus>
            <c:minus>
              <c:numRef>
                <c:f>[1]siIKKe!$P$28:$P$31</c:f>
                <c:numCache>
                  <c:formatCode>General</c:formatCode>
                  <c:ptCount val="4"/>
                  <c:pt idx="0">
                    <c:v>0.118577299499844</c:v>
                  </c:pt>
                  <c:pt idx="1">
                    <c:v>0.0816723465676937</c:v>
                  </c:pt>
                  <c:pt idx="2">
                    <c:v>0.0900206835237358</c:v>
                  </c:pt>
                  <c:pt idx="3">
                    <c:v>0.0175889285822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siIKKe!$M$28:$M$31</c:f>
              <c:strCache>
                <c:ptCount val="4"/>
                <c:pt idx="0">
                  <c:v>siNeg</c:v>
                </c:pt>
                <c:pt idx="1">
                  <c:v>siIkke</c:v>
                </c:pt>
                <c:pt idx="2">
                  <c:v>siNeg+Meki</c:v>
                </c:pt>
                <c:pt idx="3">
                  <c:v>siIkke+ Meki</c:v>
                </c:pt>
              </c:strCache>
            </c:strRef>
          </c:cat>
          <c:val>
            <c:numRef>
              <c:f>[1]siIKKe!$N$28:$N$31</c:f>
              <c:numCache>
                <c:formatCode>General</c:formatCode>
                <c:ptCount val="4"/>
                <c:pt idx="0">
                  <c:v>1.0</c:v>
                </c:pt>
                <c:pt idx="1">
                  <c:v>1.057757903473924</c:v>
                </c:pt>
                <c:pt idx="2">
                  <c:v>0.492632642796839</c:v>
                </c:pt>
                <c:pt idx="3">
                  <c:v>0.4078992466507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01C-0C4D-B221-97134AAF9D30}"/>
            </c:ext>
          </c:extLst>
        </c:ser>
        <c:ser>
          <c:idx val="1"/>
          <c:order val="1"/>
          <c:tx>
            <c:strRef>
              <c:f>'[siIKKe combined.xlsx]siIKKe'!$O$27</c:f>
              <c:strCache>
                <c:ptCount val="1"/>
                <c:pt idx="0">
                  <c:v>L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[1]siIKKe!$Q$28:$Q$31</c:f>
                <c:numCache>
                  <c:formatCode>General</c:formatCode>
                  <c:ptCount val="4"/>
                  <c:pt idx="0">
                    <c:v>0.152968733790305</c:v>
                  </c:pt>
                  <c:pt idx="1">
                    <c:v>0.102543613315304</c:v>
                  </c:pt>
                  <c:pt idx="2">
                    <c:v>0.0205576913154211</c:v>
                  </c:pt>
                  <c:pt idx="3">
                    <c:v>0.0302166280143224</c:v>
                  </c:pt>
                </c:numCache>
              </c:numRef>
            </c:plus>
            <c:minus>
              <c:numRef>
                <c:f>[1]siIKKe!$Q$28:$Q$31</c:f>
                <c:numCache>
                  <c:formatCode>General</c:formatCode>
                  <c:ptCount val="4"/>
                  <c:pt idx="0">
                    <c:v>0.152968733790305</c:v>
                  </c:pt>
                  <c:pt idx="1">
                    <c:v>0.102543613315304</c:v>
                  </c:pt>
                  <c:pt idx="2">
                    <c:v>0.0205576913154211</c:v>
                  </c:pt>
                  <c:pt idx="3">
                    <c:v>0.03021662801432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1]siIKKe!$M$28:$M$31</c:f>
              <c:strCache>
                <c:ptCount val="4"/>
                <c:pt idx="0">
                  <c:v>siNeg</c:v>
                </c:pt>
                <c:pt idx="1">
                  <c:v>siIkke</c:v>
                </c:pt>
                <c:pt idx="2">
                  <c:v>siNeg+Meki</c:v>
                </c:pt>
                <c:pt idx="3">
                  <c:v>siIkke+ Meki</c:v>
                </c:pt>
              </c:strCache>
            </c:strRef>
          </c:cat>
          <c:val>
            <c:numRef>
              <c:f>[1]siIKKe!$O$28:$O$31</c:f>
              <c:numCache>
                <c:formatCode>General</c:formatCode>
                <c:ptCount val="4"/>
                <c:pt idx="0">
                  <c:v>0.621405621656601</c:v>
                </c:pt>
                <c:pt idx="1">
                  <c:v>0.638076350368944</c:v>
                </c:pt>
                <c:pt idx="2">
                  <c:v>0.241806472289458</c:v>
                </c:pt>
                <c:pt idx="3">
                  <c:v>0.2507363499472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01C-0C4D-B221-97134AAF9D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37336912"/>
        <c:axId val="-414641696"/>
      </c:barChart>
      <c:catAx>
        <c:axId val="-53733691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414641696"/>
        <c:crosses val="autoZero"/>
        <c:auto val="1"/>
        <c:lblAlgn val="ctr"/>
        <c:lblOffset val="100"/>
        <c:noMultiLvlLbl val="0"/>
      </c:catAx>
      <c:valAx>
        <c:axId val="-414641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ell viability</a:t>
                </a:r>
              </a:p>
              <a:p>
                <a:pPr>
                  <a:defRPr/>
                </a:pPr>
                <a:r>
                  <a:rPr lang="en-US"/>
                  <a:t>(fold negative control)</a:t>
                </a:r>
              </a:p>
            </c:rich>
          </c:tx>
          <c:layout>
            <c:manualLayout>
              <c:xMode val="edge"/>
              <c:yMode val="edge"/>
              <c:x val="0.0300684448140412"/>
              <c:y val="0.24592495533895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37336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MDA 231</a:t>
            </a:r>
          </a:p>
        </c:rich>
      </c:tx>
      <c:layout>
        <c:manualLayout>
          <c:xMode val="edge"/>
          <c:yMode val="edge"/>
          <c:x val="0.473327401873917"/>
          <c:y val="0.052631694968159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2986114510618"/>
          <c:y val="0.202717930901915"/>
          <c:w val="0.716500614358864"/>
          <c:h val="0.6069105139062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A and LA RPMI'!$B$34</c:f>
              <c:strCache>
                <c:ptCount val="1"/>
                <c:pt idx="0">
                  <c:v>H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A and LA RPMI'!$C$38:$F$38</c:f>
                <c:numCache>
                  <c:formatCode>General</c:formatCode>
                  <c:ptCount val="4"/>
                  <c:pt idx="0">
                    <c:v>0.0313310292681729</c:v>
                  </c:pt>
                  <c:pt idx="1">
                    <c:v>0.0357944721996632</c:v>
                  </c:pt>
                  <c:pt idx="2">
                    <c:v>0.0810514240268674</c:v>
                  </c:pt>
                  <c:pt idx="3">
                    <c:v>0.105018247575128</c:v>
                  </c:pt>
                </c:numCache>
              </c:numRef>
            </c:plus>
            <c:minus>
              <c:numRef>
                <c:f>'HA and LA RPMI'!$C$38:$F$38</c:f>
                <c:numCache>
                  <c:formatCode>General</c:formatCode>
                  <c:ptCount val="4"/>
                  <c:pt idx="0">
                    <c:v>0.0313310292681729</c:v>
                  </c:pt>
                  <c:pt idx="1">
                    <c:v>0.0357944721996632</c:v>
                  </c:pt>
                  <c:pt idx="2">
                    <c:v>0.0810514240268674</c:v>
                  </c:pt>
                  <c:pt idx="3">
                    <c:v>0.10501824757512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A and LA RPMI'!$C$33:$F$33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HA and LA RPMI'!$C$34:$F$34</c:f>
              <c:numCache>
                <c:formatCode>General</c:formatCode>
                <c:ptCount val="4"/>
                <c:pt idx="0">
                  <c:v>1.0</c:v>
                </c:pt>
                <c:pt idx="1">
                  <c:v>1.225421791258682</c:v>
                </c:pt>
                <c:pt idx="2">
                  <c:v>1.15203537935528</c:v>
                </c:pt>
                <c:pt idx="3">
                  <c:v>0.9632498962835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EF8-8049-A25B-319E10AA0A78}"/>
            </c:ext>
          </c:extLst>
        </c:ser>
        <c:ser>
          <c:idx val="1"/>
          <c:order val="1"/>
          <c:tx>
            <c:strRef>
              <c:f>'HA and LA RPMI'!$B$35</c:f>
              <c:strCache>
                <c:ptCount val="1"/>
                <c:pt idx="0">
                  <c:v>L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A and LA RPMI'!$C$39:$F$39</c:f>
                <c:numCache>
                  <c:formatCode>General</c:formatCode>
                  <c:ptCount val="4"/>
                  <c:pt idx="0">
                    <c:v>0.0166933223324728</c:v>
                  </c:pt>
                  <c:pt idx="1">
                    <c:v>0.011292768690315</c:v>
                  </c:pt>
                  <c:pt idx="2">
                    <c:v>0.00736135040478032</c:v>
                  </c:pt>
                  <c:pt idx="3">
                    <c:v>0.0161311239955226</c:v>
                  </c:pt>
                </c:numCache>
              </c:numRef>
            </c:plus>
            <c:minus>
              <c:numRef>
                <c:f>'HA and LA RPMI'!$C$39:$F$39</c:f>
                <c:numCache>
                  <c:formatCode>General</c:formatCode>
                  <c:ptCount val="4"/>
                  <c:pt idx="0">
                    <c:v>0.0166933223324728</c:v>
                  </c:pt>
                  <c:pt idx="1">
                    <c:v>0.011292768690315</c:v>
                  </c:pt>
                  <c:pt idx="2">
                    <c:v>0.00736135040478032</c:v>
                  </c:pt>
                  <c:pt idx="3">
                    <c:v>0.01613112399552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A and LA RPMI'!$C$33:$F$33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HA and LA RPMI'!$C$35:$F$35</c:f>
              <c:numCache>
                <c:formatCode>General</c:formatCode>
                <c:ptCount val="4"/>
                <c:pt idx="0">
                  <c:v>0.25992855519064</c:v>
                </c:pt>
                <c:pt idx="1">
                  <c:v>0.365315405369252</c:v>
                </c:pt>
                <c:pt idx="2">
                  <c:v>0.277249937684981</c:v>
                </c:pt>
                <c:pt idx="3">
                  <c:v>0.2322894684327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EF8-8049-A25B-319E10AA0A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68641264"/>
        <c:axId val="-537945504"/>
      </c:barChart>
      <c:catAx>
        <c:axId val="-56864126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537945504"/>
        <c:crosses val="autoZero"/>
        <c:auto val="1"/>
        <c:lblAlgn val="ctr"/>
        <c:lblOffset val="100"/>
        <c:noMultiLvlLbl val="0"/>
      </c:catAx>
      <c:valAx>
        <c:axId val="-5379455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ell viability </a:t>
                </a:r>
              </a:p>
              <a:p>
                <a:pPr>
                  <a:defRPr/>
                </a:pPr>
                <a:r>
                  <a:rPr lang="en-US" dirty="0"/>
                  <a:t>(fold negative</a:t>
                </a:r>
                <a:r>
                  <a:rPr lang="en-US" baseline="0" dirty="0"/>
                  <a:t> control)</a:t>
                </a:r>
                <a:endParaRPr lang="en-US" dirty="0"/>
              </a:p>
            </c:rich>
          </c:tx>
          <c:layout>
            <c:manualLayout>
              <c:xMode val="edge"/>
              <c:yMode val="edge"/>
              <c:x val="0.0238807531892813"/>
              <c:y val="0.19313983447638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68641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880953206556"/>
          <c:y val="0.10358804865397"/>
          <c:w val="0.699145914518318"/>
          <c:h val="0.822011255491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A and LA RPMI'!$V$34</c:f>
              <c:strCache>
                <c:ptCount val="1"/>
                <c:pt idx="0">
                  <c:v>H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A and LA RPMI'!$W$38:$Z$38</c:f>
                <c:numCache>
                  <c:formatCode>General</c:formatCode>
                  <c:ptCount val="4"/>
                  <c:pt idx="0">
                    <c:v>0.0253683720955005</c:v>
                  </c:pt>
                  <c:pt idx="1">
                    <c:v>0.0402941677712647</c:v>
                  </c:pt>
                  <c:pt idx="2">
                    <c:v>0.0352762429297873</c:v>
                  </c:pt>
                  <c:pt idx="3">
                    <c:v>0.0472792213366239</c:v>
                  </c:pt>
                </c:numCache>
              </c:numRef>
            </c:plus>
            <c:minus>
              <c:numRef>
                <c:f>'HA and LA RPMI'!$W$38:$Z$38</c:f>
                <c:numCache>
                  <c:formatCode>General</c:formatCode>
                  <c:ptCount val="4"/>
                  <c:pt idx="0">
                    <c:v>0.0253683720955005</c:v>
                  </c:pt>
                  <c:pt idx="1">
                    <c:v>0.0402941677712647</c:v>
                  </c:pt>
                  <c:pt idx="2">
                    <c:v>0.0352762429297873</c:v>
                  </c:pt>
                  <c:pt idx="3">
                    <c:v>0.047279221336623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A and LA RPMI'!$W$33:$Z$33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HA and LA RPMI'!$W$34:$Z$34</c:f>
              <c:numCache>
                <c:formatCode>General</c:formatCode>
                <c:ptCount val="4"/>
                <c:pt idx="0">
                  <c:v>1.0</c:v>
                </c:pt>
                <c:pt idx="1">
                  <c:v>0.468938258176167</c:v>
                </c:pt>
                <c:pt idx="2">
                  <c:v>1.01215407606719</c:v>
                </c:pt>
                <c:pt idx="3">
                  <c:v>0.64198937793028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B70-A04E-951E-17B025BE56A0}"/>
            </c:ext>
          </c:extLst>
        </c:ser>
        <c:ser>
          <c:idx val="1"/>
          <c:order val="1"/>
          <c:tx>
            <c:strRef>
              <c:f>'HA and LA RPMI'!$V$35</c:f>
              <c:strCache>
                <c:ptCount val="1"/>
                <c:pt idx="0">
                  <c:v>L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HA and LA RPMI'!$W$39:$Z$39</c:f>
                <c:numCache>
                  <c:formatCode>General</c:formatCode>
                  <c:ptCount val="4"/>
                  <c:pt idx="0">
                    <c:v>0.0157309954682062</c:v>
                  </c:pt>
                  <c:pt idx="1">
                    <c:v>0.0206391524503075</c:v>
                  </c:pt>
                  <c:pt idx="2">
                    <c:v>0.0502398757651636</c:v>
                  </c:pt>
                  <c:pt idx="3">
                    <c:v>0.0222879706628704</c:v>
                  </c:pt>
                </c:numCache>
              </c:numRef>
            </c:plus>
            <c:minus>
              <c:numRef>
                <c:f>'HA and LA RPMI'!$W$39:$Z$39</c:f>
                <c:numCache>
                  <c:formatCode>General</c:formatCode>
                  <c:ptCount val="4"/>
                  <c:pt idx="0">
                    <c:v>0.0157309954682062</c:v>
                  </c:pt>
                  <c:pt idx="1">
                    <c:v>0.0206391524503075</c:v>
                  </c:pt>
                  <c:pt idx="2">
                    <c:v>0.0502398757651636</c:v>
                  </c:pt>
                  <c:pt idx="3">
                    <c:v>0.02228797066287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HA and LA RPMI'!$W$33:$Z$33</c:f>
              <c:strCache>
                <c:ptCount val="4"/>
                <c:pt idx="0">
                  <c:v>shNeg siNeg</c:v>
                </c:pt>
                <c:pt idx="1">
                  <c:v>shIKKE siNeg</c:v>
                </c:pt>
                <c:pt idx="2">
                  <c:v>shNeg sip52</c:v>
                </c:pt>
                <c:pt idx="3">
                  <c:v>shIKKe sip52</c:v>
                </c:pt>
              </c:strCache>
            </c:strRef>
          </c:cat>
          <c:val>
            <c:numRef>
              <c:f>'HA and LA RPMI'!$W$35:$Z$35</c:f>
              <c:numCache>
                <c:formatCode>General</c:formatCode>
                <c:ptCount val="4"/>
                <c:pt idx="0">
                  <c:v>0.442430026857715</c:v>
                </c:pt>
                <c:pt idx="1">
                  <c:v>0.311950243210082</c:v>
                </c:pt>
                <c:pt idx="2">
                  <c:v>0.379676998337006</c:v>
                </c:pt>
                <c:pt idx="3">
                  <c:v>0.1517683688085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B70-A04E-951E-17B025BE56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4"/>
        <c:overlap val="-27"/>
        <c:axId val="-420947952"/>
        <c:axId val="-533153312"/>
      </c:barChart>
      <c:catAx>
        <c:axId val="-4209479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533153312"/>
        <c:crosses val="autoZero"/>
        <c:auto val="1"/>
        <c:lblAlgn val="ctr"/>
        <c:lblOffset val="100"/>
        <c:noMultiLvlLbl val="0"/>
      </c:catAx>
      <c:valAx>
        <c:axId val="-5331533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Cell viability </a:t>
                </a:r>
              </a:p>
              <a:p>
                <a:pPr>
                  <a:defRPr/>
                </a:pPr>
                <a:r>
                  <a:rPr lang="en-US" dirty="0"/>
                  <a:t>(fold negative control)</a:t>
                </a:r>
              </a:p>
            </c:rich>
          </c:tx>
          <c:layout>
            <c:manualLayout>
              <c:xMode val="edge"/>
              <c:yMode val="edge"/>
              <c:x val="0.0191789380641444"/>
              <c:y val="0.25285863976452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09479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38544387636217"/>
          <c:y val="0.0807194791829795"/>
          <c:w val="0.711558263088685"/>
          <c:h val="0.80155797668851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iIKKe!$N$10</c:f>
              <c:strCache>
                <c:ptCount val="1"/>
                <c:pt idx="0">
                  <c:v>HA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iIKKe!$P$11:$P$14</c:f>
                <c:numCache>
                  <c:formatCode>General</c:formatCode>
                  <c:ptCount val="4"/>
                  <c:pt idx="0">
                    <c:v>0.0713517339455649</c:v>
                  </c:pt>
                  <c:pt idx="1">
                    <c:v>0.217663715402842</c:v>
                  </c:pt>
                  <c:pt idx="2">
                    <c:v>0.0648131884464621</c:v>
                  </c:pt>
                  <c:pt idx="3">
                    <c:v>0.147952798978</c:v>
                  </c:pt>
                </c:numCache>
              </c:numRef>
            </c:plus>
            <c:minus>
              <c:numRef>
                <c:f>siIKKe!$P$11:$P$14</c:f>
                <c:numCache>
                  <c:formatCode>General</c:formatCode>
                  <c:ptCount val="4"/>
                  <c:pt idx="0">
                    <c:v>0.0713517339455649</c:v>
                  </c:pt>
                  <c:pt idx="1">
                    <c:v>0.217663715402842</c:v>
                  </c:pt>
                  <c:pt idx="2">
                    <c:v>0.0648131884464621</c:v>
                  </c:pt>
                  <c:pt idx="3">
                    <c:v>0.1479527989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iIKKe!$M$11:$M$14</c:f>
              <c:strCache>
                <c:ptCount val="4"/>
                <c:pt idx="0">
                  <c:v>siNeg</c:v>
                </c:pt>
                <c:pt idx="1">
                  <c:v>siIkke</c:v>
                </c:pt>
                <c:pt idx="2">
                  <c:v>siNeg+Meki</c:v>
                </c:pt>
                <c:pt idx="3">
                  <c:v>siIkke+ Meki</c:v>
                </c:pt>
              </c:strCache>
            </c:strRef>
          </c:cat>
          <c:val>
            <c:numRef>
              <c:f>siIKKe!$N$11:$N$14</c:f>
              <c:numCache>
                <c:formatCode>General</c:formatCode>
                <c:ptCount val="4"/>
                <c:pt idx="0">
                  <c:v>1.0</c:v>
                </c:pt>
                <c:pt idx="1">
                  <c:v>1.252012204330196</c:v>
                </c:pt>
                <c:pt idx="2">
                  <c:v>0.895034897052074</c:v>
                </c:pt>
                <c:pt idx="3">
                  <c:v>0.8633102734111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785-7446-AEC7-06E81912F228}"/>
            </c:ext>
          </c:extLst>
        </c:ser>
        <c:ser>
          <c:idx val="1"/>
          <c:order val="1"/>
          <c:tx>
            <c:strRef>
              <c:f>siIKKe!$O$10</c:f>
              <c:strCache>
                <c:ptCount val="1"/>
                <c:pt idx="0">
                  <c:v>L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iIKKe!$Q$11:$Q$14</c:f>
                <c:numCache>
                  <c:formatCode>General</c:formatCode>
                  <c:ptCount val="4"/>
                  <c:pt idx="0">
                    <c:v>0.149563913271344</c:v>
                  </c:pt>
                  <c:pt idx="1">
                    <c:v>0.222552025992225</c:v>
                  </c:pt>
                  <c:pt idx="2">
                    <c:v>0.0268925659718569</c:v>
                  </c:pt>
                  <c:pt idx="3">
                    <c:v>0.0247924085582243</c:v>
                  </c:pt>
                </c:numCache>
              </c:numRef>
            </c:plus>
            <c:minus>
              <c:numRef>
                <c:f>siIKKe!$Q$11:$Q$14</c:f>
                <c:numCache>
                  <c:formatCode>General</c:formatCode>
                  <c:ptCount val="4"/>
                  <c:pt idx="0">
                    <c:v>0.149563913271344</c:v>
                  </c:pt>
                  <c:pt idx="1">
                    <c:v>0.222552025992225</c:v>
                  </c:pt>
                  <c:pt idx="2">
                    <c:v>0.0268925659718569</c:v>
                  </c:pt>
                  <c:pt idx="3">
                    <c:v>0.02479240855822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iIKKe!$M$11:$M$14</c:f>
              <c:strCache>
                <c:ptCount val="4"/>
                <c:pt idx="0">
                  <c:v>siNeg</c:v>
                </c:pt>
                <c:pt idx="1">
                  <c:v>siIkke</c:v>
                </c:pt>
                <c:pt idx="2">
                  <c:v>siNeg+Meki</c:v>
                </c:pt>
                <c:pt idx="3">
                  <c:v>siIkke+ Meki</c:v>
                </c:pt>
              </c:strCache>
            </c:strRef>
          </c:cat>
          <c:val>
            <c:numRef>
              <c:f>siIKKe!$O$11:$O$14</c:f>
              <c:numCache>
                <c:formatCode>General</c:formatCode>
                <c:ptCount val="4"/>
                <c:pt idx="0">
                  <c:v>0.67761025202236</c:v>
                </c:pt>
                <c:pt idx="1">
                  <c:v>0.66403059782374</c:v>
                </c:pt>
                <c:pt idx="2">
                  <c:v>0.550151645339238</c:v>
                </c:pt>
                <c:pt idx="3">
                  <c:v>0.2969991058090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785-7446-AEC7-06E81912F2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29"/>
        <c:overlap val="-27"/>
        <c:axId val="-563269776"/>
        <c:axId val="-421042208"/>
      </c:barChart>
      <c:catAx>
        <c:axId val="-56326977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421042208"/>
        <c:crosses val="autoZero"/>
        <c:auto val="1"/>
        <c:lblAlgn val="ctr"/>
        <c:lblOffset val="100"/>
        <c:noMultiLvlLbl val="0"/>
      </c:catAx>
      <c:valAx>
        <c:axId val="-4210422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Cell viability</a:t>
                </a:r>
              </a:p>
              <a:p>
                <a:pPr>
                  <a:defRPr/>
                </a:pPr>
                <a:r>
                  <a:rPr lang="en-US"/>
                  <a:t>(fold negative control)</a:t>
                </a:r>
              </a:p>
            </c:rich>
          </c:tx>
          <c:layout>
            <c:manualLayout>
              <c:xMode val="edge"/>
              <c:yMode val="edge"/>
              <c:x val="0.0439934845682487"/>
              <c:y val="0.17360380936649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63269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chart" Target="../charts/chart3.xml"/><Relationship Id="rId1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4" Type="http://schemas.openxmlformats.org/officeDocument/2006/relationships/image" Target="../media/image1.tiff"/><Relationship Id="rId5" Type="http://schemas.openxmlformats.org/officeDocument/2006/relationships/image" Target="../media/image2.tiff"/><Relationship Id="rId6" Type="http://schemas.openxmlformats.org/officeDocument/2006/relationships/image" Target="../media/image3.tiff"/><Relationship Id="rId7" Type="http://schemas.openxmlformats.org/officeDocument/2006/relationships/image" Target="../media/image4.tiff"/><Relationship Id="rId8" Type="http://schemas.openxmlformats.org/officeDocument/2006/relationships/image" Target="../media/image5.tiff"/><Relationship Id="rId9" Type="http://schemas.openxmlformats.org/officeDocument/2006/relationships/image" Target="../media/image6.tiff"/><Relationship Id="rId10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/>
          <p:cNvGrpSpPr/>
          <p:nvPr/>
        </p:nvGrpSpPr>
        <p:grpSpPr>
          <a:xfrm>
            <a:off x="3436482" y="3505774"/>
            <a:ext cx="3249187" cy="2609561"/>
            <a:chOff x="3433425" y="3704097"/>
            <a:chExt cx="3249187" cy="2268196"/>
          </a:xfrm>
        </p:grpSpPr>
        <p:graphicFrame>
          <p:nvGraphicFramePr>
            <p:cNvPr id="54" name="Chart 5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1647544"/>
                </p:ext>
              </p:extLst>
            </p:nvPr>
          </p:nvGraphicFramePr>
          <p:xfrm>
            <a:off x="3433425" y="3704097"/>
            <a:ext cx="3249187" cy="22681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55" name="Group 54"/>
            <p:cNvGrpSpPr/>
            <p:nvPr/>
          </p:nvGrpSpPr>
          <p:grpSpPr>
            <a:xfrm>
              <a:off x="3499595" y="5567008"/>
              <a:ext cx="3035531" cy="358406"/>
              <a:chOff x="3204270" y="2325405"/>
              <a:chExt cx="3111809" cy="447036"/>
            </a:xfrm>
          </p:grpSpPr>
          <p:sp>
            <p:nvSpPr>
              <p:cNvPr id="56" name="TextBox 55"/>
              <p:cNvSpPr txBox="1"/>
              <p:nvPr/>
            </p:nvSpPr>
            <p:spPr>
              <a:xfrm>
                <a:off x="4086149" y="2325405"/>
                <a:ext cx="4876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/>
                  <a:t>Neg</a:t>
                </a:r>
                <a:r>
                  <a:rPr lang="en-US" sz="1000" dirty="0"/>
                  <a:t> 1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5274831" y="2526220"/>
                <a:ext cx="4235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MEK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3204270" y="2325405"/>
                <a:ext cx="90762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/>
                  <a:t>shRNA</a:t>
                </a:r>
                <a:r>
                  <a:rPr lang="en-US" sz="1000" dirty="0"/>
                  <a:t> target: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3329450" y="2516296"/>
                <a:ext cx="80502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drug target:</a:t>
                </a:r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4033235" y="2526220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vehicle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5214591" y="2325405"/>
                <a:ext cx="4876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/>
                  <a:t>Neg</a:t>
                </a:r>
                <a:r>
                  <a:rPr lang="en-US" sz="1000" dirty="0"/>
                  <a:t> 1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4606956" y="2325405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/>
                  <a:t>IKK</a:t>
                </a:r>
                <a:r>
                  <a:rPr lang="en-US" sz="1000" dirty="0" err="1">
                    <a:latin typeface="Symbol" charset="2"/>
                    <a:cs typeface="Symbol" charset="2"/>
                  </a:rPr>
                  <a:t>e</a:t>
                </a:r>
                <a:r>
                  <a:rPr lang="en-US" sz="1000" dirty="0">
                    <a:latin typeface="Symbol" charset="2"/>
                    <a:cs typeface="Symbol" charset="2"/>
                  </a:rPr>
                  <a:t> </a:t>
                </a:r>
                <a:r>
                  <a:rPr lang="en-US" sz="1000" dirty="0">
                    <a:cs typeface="Symbol" charset="2"/>
                  </a:rPr>
                  <a:t>1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63" name="TextBox 62"/>
              <p:cNvSpPr txBox="1"/>
              <p:nvPr/>
            </p:nvSpPr>
            <p:spPr>
              <a:xfrm>
                <a:off x="5810812" y="2325405"/>
                <a:ext cx="50526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err="1"/>
                  <a:t>IKK</a:t>
                </a:r>
                <a:r>
                  <a:rPr lang="en-US" sz="1000" dirty="0" err="1">
                    <a:latin typeface="Symbol" charset="2"/>
                    <a:cs typeface="Symbol" charset="2"/>
                  </a:rPr>
                  <a:t>e</a:t>
                </a:r>
                <a:r>
                  <a:rPr lang="en-US" sz="1000" dirty="0">
                    <a:latin typeface="Symbol" charset="2"/>
                    <a:cs typeface="Symbol" charset="2"/>
                  </a:rPr>
                  <a:t> </a:t>
                </a:r>
                <a:r>
                  <a:rPr lang="en-US" sz="1000" dirty="0">
                    <a:cs typeface="Symbol" charset="2"/>
                  </a:rPr>
                  <a:t>1</a:t>
                </a:r>
                <a:endParaRPr lang="en-US" sz="1000" dirty="0">
                  <a:latin typeface="Symbol" charset="2"/>
                  <a:cs typeface="Symbol" charset="2"/>
                </a:endParaRPr>
              </a:p>
            </p:txBody>
          </p:sp>
          <p:sp>
            <p:nvSpPr>
              <p:cNvPr id="64" name="TextBox 63"/>
              <p:cNvSpPr txBox="1"/>
              <p:nvPr/>
            </p:nvSpPr>
            <p:spPr>
              <a:xfrm>
                <a:off x="5828212" y="2516793"/>
                <a:ext cx="42351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MEK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4616325" y="2526220"/>
                <a:ext cx="5501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/>
                  <a:t>vehicle</a:t>
                </a:r>
              </a:p>
            </p:txBody>
          </p:sp>
        </p:grpSp>
        <p:grpSp>
          <p:nvGrpSpPr>
            <p:cNvPr id="66" name="Group 65"/>
            <p:cNvGrpSpPr/>
            <p:nvPr/>
          </p:nvGrpSpPr>
          <p:grpSpPr>
            <a:xfrm>
              <a:off x="5150204" y="4199061"/>
              <a:ext cx="1195904" cy="418960"/>
              <a:chOff x="5052767" y="832737"/>
              <a:chExt cx="1189349" cy="735361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>
                <a:off x="5052767" y="832737"/>
                <a:ext cx="0" cy="7258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>
                <a:off x="6242116" y="842234"/>
                <a:ext cx="0" cy="7258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 flipH="1">
                <a:off x="5052767" y="844690"/>
                <a:ext cx="1189349" cy="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0" name="Group 69"/>
            <p:cNvGrpSpPr/>
            <p:nvPr/>
          </p:nvGrpSpPr>
          <p:grpSpPr>
            <a:xfrm>
              <a:off x="5791996" y="4357771"/>
              <a:ext cx="554111" cy="692049"/>
              <a:chOff x="5052767" y="842234"/>
              <a:chExt cx="1189349" cy="725864"/>
            </a:xfrm>
          </p:grpSpPr>
          <p:cxnSp>
            <p:nvCxnSpPr>
              <p:cNvPr id="71" name="Straight Connector 70"/>
              <p:cNvCxnSpPr/>
              <p:nvPr/>
            </p:nvCxnSpPr>
            <p:spPr>
              <a:xfrm>
                <a:off x="5052767" y="842234"/>
                <a:ext cx="0" cy="7258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/>
              <p:nvPr/>
            </p:nvCxnSpPr>
            <p:spPr>
              <a:xfrm>
                <a:off x="6242116" y="842234"/>
                <a:ext cx="0" cy="7258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 flipH="1">
                <a:off x="5052767" y="850382"/>
                <a:ext cx="1189349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4" name="TextBox 73"/>
            <p:cNvSpPr txBox="1"/>
            <p:nvPr/>
          </p:nvSpPr>
          <p:spPr>
            <a:xfrm>
              <a:off x="5568208" y="3971075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  <p:cxnSp>
          <p:nvCxnSpPr>
            <p:cNvPr id="75" name="Straight Connector 74"/>
            <p:cNvCxnSpPr/>
            <p:nvPr/>
          </p:nvCxnSpPr>
          <p:spPr>
            <a:xfrm>
              <a:off x="5791996" y="4406726"/>
              <a:ext cx="0" cy="522042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5943531" y="4148183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s</a:t>
              </a:r>
            </a:p>
          </p:txBody>
        </p:sp>
        <p:cxnSp>
          <p:nvCxnSpPr>
            <p:cNvPr id="77" name="Straight Connector 76"/>
            <p:cNvCxnSpPr/>
            <p:nvPr/>
          </p:nvCxnSpPr>
          <p:spPr>
            <a:xfrm flipH="1">
              <a:off x="5156151" y="4375914"/>
              <a:ext cx="554111" cy="1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5713237" y="4368626"/>
              <a:ext cx="500" cy="681194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/>
            <p:cNvSpPr txBox="1"/>
            <p:nvPr/>
          </p:nvSpPr>
          <p:spPr>
            <a:xfrm>
              <a:off x="5316094" y="4188011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*</a:t>
              </a:r>
            </a:p>
          </p:txBody>
        </p:sp>
      </p:grp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68101781"/>
              </p:ext>
            </p:extLst>
          </p:nvPr>
        </p:nvGraphicFramePr>
        <p:xfrm>
          <a:off x="3349966" y="888295"/>
          <a:ext cx="3268448" cy="22681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4" name="Group 13"/>
          <p:cNvGrpSpPr/>
          <p:nvPr/>
        </p:nvGrpSpPr>
        <p:grpSpPr>
          <a:xfrm>
            <a:off x="5050812" y="1349002"/>
            <a:ext cx="1217508" cy="885016"/>
            <a:chOff x="5052767" y="842234"/>
            <a:chExt cx="1189349" cy="885016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5052767" y="842234"/>
              <a:ext cx="0" cy="885016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/>
          </p:nvCxnSpPr>
          <p:spPr>
            <a:xfrm>
              <a:off x="6242116" y="842234"/>
              <a:ext cx="0" cy="725864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>
              <a:off x="5052767" y="853355"/>
              <a:ext cx="1189349" cy="1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TextBox 14"/>
          <p:cNvSpPr txBox="1"/>
          <p:nvPr/>
        </p:nvSpPr>
        <p:spPr>
          <a:xfrm>
            <a:off x="5316780" y="1170219"/>
            <a:ext cx="6014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P = 0.07</a:t>
            </a:r>
          </a:p>
        </p:txBody>
      </p:sp>
      <p:grpSp>
        <p:nvGrpSpPr>
          <p:cNvPr id="16" name="Group 15"/>
          <p:cNvGrpSpPr/>
          <p:nvPr/>
        </p:nvGrpSpPr>
        <p:grpSpPr>
          <a:xfrm>
            <a:off x="5667092" y="1540402"/>
            <a:ext cx="601228" cy="725864"/>
            <a:chOff x="5052767" y="842234"/>
            <a:chExt cx="1189349" cy="725864"/>
          </a:xfrm>
        </p:grpSpPr>
        <p:cxnSp>
          <p:nvCxnSpPr>
            <p:cNvPr id="17" name="Straight Connector 16"/>
            <p:cNvCxnSpPr/>
            <p:nvPr/>
          </p:nvCxnSpPr>
          <p:spPr>
            <a:xfrm>
              <a:off x="5052767" y="842234"/>
              <a:ext cx="0" cy="725864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6242116" y="842234"/>
              <a:ext cx="0" cy="725864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H="1">
              <a:off x="5052767" y="853823"/>
              <a:ext cx="1189349" cy="1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5797159" y="1344703"/>
            <a:ext cx="3016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ns</a:t>
            </a:r>
          </a:p>
        </p:txBody>
      </p:sp>
      <p:grpSp>
        <p:nvGrpSpPr>
          <p:cNvPr id="43" name="Group 42"/>
          <p:cNvGrpSpPr/>
          <p:nvPr/>
        </p:nvGrpSpPr>
        <p:grpSpPr>
          <a:xfrm>
            <a:off x="3205780" y="2680706"/>
            <a:ext cx="3316272" cy="442116"/>
            <a:chOff x="53822" y="2457383"/>
            <a:chExt cx="3023014" cy="442116"/>
          </a:xfrm>
        </p:grpSpPr>
        <p:sp>
          <p:nvSpPr>
            <p:cNvPr id="44" name="TextBox 43"/>
            <p:cNvSpPr txBox="1"/>
            <p:nvPr/>
          </p:nvSpPr>
          <p:spPr>
            <a:xfrm>
              <a:off x="988311" y="2457383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062897" y="2653278"/>
              <a:ext cx="483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FKB2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3822" y="2457383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99358" y="2648274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i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988311" y="2653278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050762" y="2457383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1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525604" y="2653278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509117" y="245738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571569" y="2457383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1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2588969" y="2653278"/>
              <a:ext cx="48396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FKB2</a:t>
              </a:r>
            </a:p>
          </p:txBody>
        </p:sp>
      </p:grpSp>
      <p:cxnSp>
        <p:nvCxnSpPr>
          <p:cNvPr id="80" name="Straight Connector 79"/>
          <p:cNvCxnSpPr/>
          <p:nvPr/>
        </p:nvCxnSpPr>
        <p:spPr>
          <a:xfrm flipH="1">
            <a:off x="5061076" y="1551991"/>
            <a:ext cx="534783" cy="1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5595859" y="1540402"/>
            <a:ext cx="0" cy="725864"/>
          </a:xfrm>
          <a:prstGeom prst="line">
            <a:avLst/>
          </a:prstGeom>
          <a:ln w="1905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 flipH="1">
            <a:off x="5119888" y="1344703"/>
            <a:ext cx="43175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ns</a:t>
            </a:r>
          </a:p>
        </p:txBody>
      </p:sp>
      <p:grpSp>
        <p:nvGrpSpPr>
          <p:cNvPr id="185" name="Group 184"/>
          <p:cNvGrpSpPr/>
          <p:nvPr/>
        </p:nvGrpSpPr>
        <p:grpSpPr>
          <a:xfrm>
            <a:off x="327992" y="6505482"/>
            <a:ext cx="2525505" cy="2355089"/>
            <a:chOff x="-149349" y="521486"/>
            <a:chExt cx="2525505" cy="2355089"/>
          </a:xfrm>
        </p:grpSpPr>
        <p:sp>
          <p:nvSpPr>
            <p:cNvPr id="186" name="TextBox 20"/>
            <p:cNvSpPr txBox="1">
              <a:spLocks noChangeArrowheads="1"/>
            </p:cNvSpPr>
            <p:nvPr/>
          </p:nvSpPr>
          <p:spPr bwMode="auto">
            <a:xfrm>
              <a:off x="469001" y="979873"/>
              <a:ext cx="453619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err="1">
                  <a:latin typeface="Calibri" charset="0"/>
                </a:rPr>
                <a:t>IKKε</a:t>
              </a:r>
              <a:endParaRPr lang="en-US" sz="1200" dirty="0">
                <a:latin typeface="Calibri" charset="0"/>
              </a:endParaRPr>
            </a:p>
          </p:txBody>
        </p:sp>
        <p:sp>
          <p:nvSpPr>
            <p:cNvPr id="187" name="TextBox 16"/>
            <p:cNvSpPr txBox="1">
              <a:spLocks noChangeArrowheads="1"/>
            </p:cNvSpPr>
            <p:nvPr/>
          </p:nvSpPr>
          <p:spPr bwMode="auto">
            <a:xfrm>
              <a:off x="422936" y="1256004"/>
              <a:ext cx="49969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Calibri" charset="0"/>
                </a:rPr>
                <a:t>p100</a:t>
              </a:r>
            </a:p>
          </p:txBody>
        </p:sp>
        <p:sp>
          <p:nvSpPr>
            <p:cNvPr id="188" name="TextBox 16"/>
            <p:cNvSpPr txBox="1">
              <a:spLocks noChangeArrowheads="1"/>
            </p:cNvSpPr>
            <p:nvPr/>
          </p:nvSpPr>
          <p:spPr bwMode="auto">
            <a:xfrm>
              <a:off x="500934" y="1529724"/>
              <a:ext cx="42167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Calibri" charset="0"/>
                </a:rPr>
                <a:t>p52</a:t>
              </a:r>
            </a:p>
          </p:txBody>
        </p:sp>
        <p:sp>
          <p:nvSpPr>
            <p:cNvPr id="189" name="TextBox 25"/>
            <p:cNvSpPr txBox="1">
              <a:spLocks noChangeArrowheads="1"/>
            </p:cNvSpPr>
            <p:nvPr/>
          </p:nvSpPr>
          <p:spPr bwMode="auto">
            <a:xfrm>
              <a:off x="176327" y="2078588"/>
              <a:ext cx="780387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 err="1">
                  <a:latin typeface="Calibri" charset="0"/>
                </a:rPr>
                <a:t>pERK</a:t>
              </a:r>
              <a:r>
                <a:rPr lang="en-US" sz="1200" dirty="0">
                  <a:latin typeface="Calibri" charset="0"/>
                </a:rPr>
                <a:t> 1/2</a:t>
              </a:r>
            </a:p>
          </p:txBody>
        </p:sp>
        <p:sp>
          <p:nvSpPr>
            <p:cNvPr id="190" name="TextBox 25"/>
            <p:cNvSpPr txBox="1">
              <a:spLocks noChangeArrowheads="1"/>
            </p:cNvSpPr>
            <p:nvPr/>
          </p:nvSpPr>
          <p:spPr bwMode="auto">
            <a:xfrm>
              <a:off x="-62180" y="2337337"/>
              <a:ext cx="103572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>
                  <a:latin typeface="Calibri" charset="0"/>
                </a:rPr>
                <a:t>Total ERK 1/2</a:t>
              </a:r>
              <a:endParaRPr lang="en-US" sz="1200" dirty="0">
                <a:latin typeface="Calibri" charset="0"/>
              </a:endParaRPr>
            </a:p>
          </p:txBody>
        </p:sp>
        <p:sp>
          <p:nvSpPr>
            <p:cNvPr id="191" name="TextBox 190"/>
            <p:cNvSpPr txBox="1">
              <a:spLocks noChangeArrowheads="1"/>
            </p:cNvSpPr>
            <p:nvPr/>
          </p:nvSpPr>
          <p:spPr bwMode="auto">
            <a:xfrm>
              <a:off x="276654" y="2599576"/>
              <a:ext cx="64109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Calibri" charset="0"/>
                </a:rPr>
                <a:t>GAPDH</a:t>
              </a: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-109593" y="521486"/>
              <a:ext cx="248574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 </a:t>
              </a:r>
              <a:r>
                <a:rPr lang="en-US" sz="1200" dirty="0" err="1"/>
                <a:t>IKK</a:t>
              </a:r>
              <a:r>
                <a:rPr lang="en-US" sz="1200" dirty="0" err="1">
                  <a:latin typeface="Symbol" charset="2"/>
                  <a:ea typeface="Symbol" charset="2"/>
                  <a:cs typeface="Symbol" charset="2"/>
                </a:rPr>
                <a:t>e</a:t>
              </a:r>
              <a:r>
                <a:rPr lang="en-US" sz="1200" dirty="0"/>
                <a:t>  shRNA       -       +       -         +    </a:t>
              </a: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-149349" y="735218"/>
              <a:ext cx="24358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     P52  siRNA      -        -       +        + </a:t>
              </a:r>
            </a:p>
          </p:txBody>
        </p:sp>
        <p:pic>
          <p:nvPicPr>
            <p:cNvPr id="194" name="Picture 19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04749" y="1001845"/>
              <a:ext cx="1353564" cy="261875"/>
            </a:xfrm>
            <a:prstGeom prst="rect">
              <a:avLst/>
            </a:prstGeom>
          </p:spPr>
        </p:pic>
        <p:pic>
          <p:nvPicPr>
            <p:cNvPr id="195" name="Picture 19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904749" y="1268310"/>
              <a:ext cx="1353563" cy="283339"/>
            </a:xfrm>
            <a:prstGeom prst="rect">
              <a:avLst/>
            </a:prstGeom>
          </p:spPr>
        </p:pic>
        <p:pic>
          <p:nvPicPr>
            <p:cNvPr id="196" name="Picture 19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04749" y="1559325"/>
              <a:ext cx="1353563" cy="265687"/>
            </a:xfrm>
            <a:prstGeom prst="rect">
              <a:avLst/>
            </a:prstGeom>
          </p:spPr>
        </p:pic>
        <p:pic>
          <p:nvPicPr>
            <p:cNvPr id="197" name="Picture 196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04749" y="1834032"/>
              <a:ext cx="1344939" cy="246476"/>
            </a:xfrm>
            <a:prstGeom prst="rect">
              <a:avLst/>
            </a:prstGeom>
          </p:spPr>
        </p:pic>
        <p:pic>
          <p:nvPicPr>
            <p:cNvPr id="198" name="Picture 197"/>
            <p:cNvPicPr>
              <a:picLocks noChangeAspect="1"/>
            </p:cNvPicPr>
            <p:nvPr/>
          </p:nvPicPr>
          <p:blipFill rotWithShape="1">
            <a:blip r:embed="rId8"/>
            <a:srcRect l="4553"/>
            <a:stretch/>
          </p:blipFill>
          <p:spPr>
            <a:xfrm>
              <a:off x="904749" y="2090149"/>
              <a:ext cx="1353563" cy="234268"/>
            </a:xfrm>
            <a:prstGeom prst="rect">
              <a:avLst/>
            </a:prstGeom>
          </p:spPr>
        </p:pic>
        <p:pic>
          <p:nvPicPr>
            <p:cNvPr id="199" name="Picture 19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08849" y="2335109"/>
              <a:ext cx="1346166" cy="244360"/>
            </a:xfrm>
            <a:prstGeom prst="rect">
              <a:avLst/>
            </a:prstGeom>
          </p:spPr>
        </p:pic>
        <p:pic>
          <p:nvPicPr>
            <p:cNvPr id="200" name="Picture 199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904749" y="2592178"/>
              <a:ext cx="1361159" cy="255589"/>
            </a:xfrm>
            <a:prstGeom prst="rect">
              <a:avLst/>
            </a:prstGeom>
          </p:spPr>
        </p:pic>
        <p:sp>
          <p:nvSpPr>
            <p:cNvPr id="201" name="TextBox 16"/>
            <p:cNvSpPr txBox="1">
              <a:spLocks noChangeArrowheads="1"/>
            </p:cNvSpPr>
            <p:nvPr/>
          </p:nvSpPr>
          <p:spPr bwMode="auto">
            <a:xfrm>
              <a:off x="453811" y="1796576"/>
              <a:ext cx="539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en-US" sz="1200" dirty="0">
                  <a:latin typeface="Calibri" charset="0"/>
                </a:rPr>
                <a:t>RelB</a:t>
              </a:r>
            </a:p>
          </p:txBody>
        </p:sp>
        <p:sp>
          <p:nvSpPr>
            <p:cNvPr id="202" name="Rectangle 201"/>
            <p:cNvSpPr/>
            <p:nvPr/>
          </p:nvSpPr>
          <p:spPr>
            <a:xfrm>
              <a:off x="895233" y="990369"/>
              <a:ext cx="1370675" cy="1864159"/>
            </a:xfrm>
            <a:prstGeom prst="rect">
              <a:avLst/>
            </a:prstGeom>
            <a:noFill/>
            <a:ln w="254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>
                <a:ln w="76200" cmpd="sng">
                  <a:solidFill>
                    <a:srgbClr val="000000"/>
                  </a:solidFill>
                </a:ln>
                <a:solidFill>
                  <a:srgbClr val="FFFFFF"/>
                </a:solidFill>
                <a:ea typeface="ＭＳ Ｐゴシック" pitchFamily="1" charset="-128"/>
                <a:cs typeface="ＭＳ Ｐゴシック" pitchFamily="1" charset="-128"/>
              </a:endParaRPr>
            </a:p>
          </p:txBody>
        </p:sp>
      </p:grpSp>
      <p:sp>
        <p:nvSpPr>
          <p:cNvPr id="203" name="TextBox 202"/>
          <p:cNvSpPr txBox="1"/>
          <p:nvPr/>
        </p:nvSpPr>
        <p:spPr>
          <a:xfrm>
            <a:off x="1657713" y="6282682"/>
            <a:ext cx="992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MDA 231</a:t>
            </a:r>
          </a:p>
        </p:txBody>
      </p:sp>
      <p:sp>
        <p:nvSpPr>
          <p:cNvPr id="204" name="TextBox 203"/>
          <p:cNvSpPr txBox="1"/>
          <p:nvPr/>
        </p:nvSpPr>
        <p:spPr>
          <a:xfrm>
            <a:off x="167899" y="587113"/>
            <a:ext cx="282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graphicFrame>
        <p:nvGraphicFramePr>
          <p:cNvPr id="145" name="Chart 14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2795783"/>
              </p:ext>
            </p:extLst>
          </p:nvPr>
        </p:nvGraphicFramePr>
        <p:xfrm>
          <a:off x="118598" y="834821"/>
          <a:ext cx="3172282" cy="20343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46" name="TextBox 145"/>
          <p:cNvSpPr txBox="1"/>
          <p:nvPr/>
        </p:nvSpPr>
        <p:spPr>
          <a:xfrm>
            <a:off x="2815400" y="2176098"/>
            <a:ext cx="3711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*</a:t>
            </a:r>
          </a:p>
        </p:txBody>
      </p:sp>
      <p:graphicFrame>
        <p:nvGraphicFramePr>
          <p:cNvPr id="147" name="Chart 14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94178731"/>
              </p:ext>
            </p:extLst>
          </p:nvPr>
        </p:nvGraphicFramePr>
        <p:xfrm>
          <a:off x="87991" y="3871072"/>
          <a:ext cx="3215323" cy="19723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sp>
        <p:nvSpPr>
          <p:cNvPr id="148" name="TextBox 147"/>
          <p:cNvSpPr txBox="1"/>
          <p:nvPr/>
        </p:nvSpPr>
        <p:spPr>
          <a:xfrm>
            <a:off x="2831894" y="498978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**</a:t>
            </a:r>
          </a:p>
        </p:txBody>
      </p:sp>
      <p:grpSp>
        <p:nvGrpSpPr>
          <p:cNvPr id="149" name="Group 148"/>
          <p:cNvGrpSpPr/>
          <p:nvPr/>
        </p:nvGrpSpPr>
        <p:grpSpPr>
          <a:xfrm>
            <a:off x="17623" y="2742967"/>
            <a:ext cx="3075489" cy="442116"/>
            <a:chOff x="38033" y="4786199"/>
            <a:chExt cx="3075489" cy="442116"/>
          </a:xfrm>
        </p:grpSpPr>
        <p:sp>
          <p:nvSpPr>
            <p:cNvPr id="160" name="TextBox 159"/>
            <p:cNvSpPr txBox="1"/>
            <p:nvPr/>
          </p:nvSpPr>
          <p:spPr>
            <a:xfrm>
              <a:off x="934814" y="4786199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2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2028254" y="4982094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FKB2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8033" y="4786199"/>
              <a:ext cx="90762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h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83569" y="4977090"/>
              <a:ext cx="8691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siRNA</a:t>
              </a:r>
              <a:r>
                <a:rPr lang="en-US" sz="1000" dirty="0"/>
                <a:t> target:</a:t>
              </a: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934814" y="4982094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016119" y="4786199"/>
              <a:ext cx="4876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r>
                <a:rPr lang="en-US" sz="1000" dirty="0"/>
                <a:t> 2</a:t>
              </a: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1481534" y="4982094"/>
              <a:ext cx="3930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Neg</a:t>
              </a:r>
              <a:endParaRPr lang="en-US" sz="1000" dirty="0"/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1465047" y="478619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2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2565207" y="4786199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 err="1"/>
                <a:t>IKK</a:t>
              </a:r>
              <a:r>
                <a:rPr lang="en-US" sz="1000" dirty="0" err="1">
                  <a:latin typeface="Symbol" charset="2"/>
                  <a:cs typeface="Symbol" charset="2"/>
                </a:rPr>
                <a:t>e</a:t>
              </a:r>
              <a:r>
                <a:rPr lang="en-US" sz="1000" dirty="0">
                  <a:latin typeface="Symbol" charset="2"/>
                  <a:cs typeface="Symbol" charset="2"/>
                </a:rPr>
                <a:t> </a:t>
              </a:r>
              <a:r>
                <a:rPr lang="en-US" sz="1000" dirty="0">
                  <a:cs typeface="Symbol" charset="2"/>
                </a:rPr>
                <a:t>2</a:t>
              </a: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2582607" y="4982094"/>
              <a:ext cx="5309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NFKB2</a:t>
              </a:r>
            </a:p>
          </p:txBody>
        </p:sp>
      </p:grpSp>
      <p:sp>
        <p:nvSpPr>
          <p:cNvPr id="150" name="TextBox 149"/>
          <p:cNvSpPr txBox="1"/>
          <p:nvPr/>
        </p:nvSpPr>
        <p:spPr>
          <a:xfrm>
            <a:off x="972264" y="5634896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Neg</a:t>
            </a:r>
            <a:r>
              <a:rPr lang="en-US" sz="1000" dirty="0"/>
              <a:t> 2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2094957" y="5835711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EK</a:t>
            </a:r>
          </a:p>
        </p:txBody>
      </p:sp>
      <p:sp>
        <p:nvSpPr>
          <p:cNvPr id="152" name="TextBox 151"/>
          <p:cNvSpPr txBox="1"/>
          <p:nvPr/>
        </p:nvSpPr>
        <p:spPr>
          <a:xfrm>
            <a:off x="-3885" y="5634896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shRNA</a:t>
            </a:r>
            <a:r>
              <a:rPr lang="en-US" sz="1000" dirty="0"/>
              <a:t> target:</a:t>
            </a:r>
          </a:p>
        </p:txBody>
      </p:sp>
      <p:sp>
        <p:nvSpPr>
          <p:cNvPr id="153" name="TextBox 152"/>
          <p:cNvSpPr txBox="1"/>
          <p:nvPr/>
        </p:nvSpPr>
        <p:spPr>
          <a:xfrm>
            <a:off x="100043" y="5860888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drug target:</a:t>
            </a:r>
          </a:p>
        </p:txBody>
      </p:sp>
      <p:sp>
        <p:nvSpPr>
          <p:cNvPr id="154" name="TextBox 153"/>
          <p:cNvSpPr txBox="1"/>
          <p:nvPr/>
        </p:nvSpPr>
        <p:spPr>
          <a:xfrm>
            <a:off x="898098" y="5870812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ehicle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2034717" y="5634896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Neg</a:t>
            </a:r>
            <a:r>
              <a:rPr lang="en-US" sz="1000" dirty="0"/>
              <a:t> 2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1493071" y="5634896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IKK</a:t>
            </a:r>
            <a:r>
              <a:rPr lang="en-US" sz="1000" dirty="0" err="1">
                <a:latin typeface="Symbol" charset="2"/>
                <a:cs typeface="Symbol" charset="2"/>
              </a:rPr>
              <a:t>e</a:t>
            </a:r>
            <a:r>
              <a:rPr lang="en-US" sz="1000" dirty="0">
                <a:latin typeface="Symbol" charset="2"/>
                <a:cs typeface="Symbol" charset="2"/>
              </a:rPr>
              <a:t> </a:t>
            </a:r>
            <a:r>
              <a:rPr lang="en-US" sz="1000" dirty="0">
                <a:cs typeface="Symbol" charset="2"/>
              </a:rPr>
              <a:t>2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2583804" y="5634896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/>
              <a:t>IKK</a:t>
            </a:r>
            <a:r>
              <a:rPr lang="en-US" sz="1000" dirty="0" err="1">
                <a:latin typeface="Symbol" charset="2"/>
                <a:cs typeface="Symbol" charset="2"/>
              </a:rPr>
              <a:t>e</a:t>
            </a:r>
            <a:r>
              <a:rPr lang="en-US" sz="1000" dirty="0">
                <a:latin typeface="Symbol" charset="2"/>
                <a:cs typeface="Symbol" charset="2"/>
              </a:rPr>
              <a:t> </a:t>
            </a:r>
            <a:r>
              <a:rPr lang="en-US" sz="1000" dirty="0">
                <a:cs typeface="Symbol" charset="2"/>
              </a:rPr>
              <a:t>2</a:t>
            </a:r>
            <a:endParaRPr lang="en-US" sz="1000" dirty="0">
              <a:latin typeface="Symbol" charset="2"/>
              <a:cs typeface="Symbol" charset="2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601204" y="5835711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MEK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1462334" y="5870812"/>
            <a:ext cx="550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vehicle</a:t>
            </a:r>
          </a:p>
        </p:txBody>
      </p:sp>
      <p:sp>
        <p:nvSpPr>
          <p:cNvPr id="170" name="TextBox 169"/>
          <p:cNvSpPr txBox="1"/>
          <p:nvPr/>
        </p:nvSpPr>
        <p:spPr>
          <a:xfrm>
            <a:off x="1633284" y="734994"/>
            <a:ext cx="769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 468</a:t>
            </a:r>
          </a:p>
        </p:txBody>
      </p:sp>
      <p:sp>
        <p:nvSpPr>
          <p:cNvPr id="171" name="TextBox 170"/>
          <p:cNvSpPr txBox="1"/>
          <p:nvPr/>
        </p:nvSpPr>
        <p:spPr>
          <a:xfrm>
            <a:off x="1632821" y="3638829"/>
            <a:ext cx="7691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 468</a:t>
            </a:r>
          </a:p>
        </p:txBody>
      </p:sp>
      <p:grpSp>
        <p:nvGrpSpPr>
          <p:cNvPr id="90" name="Group 89"/>
          <p:cNvGrpSpPr/>
          <p:nvPr/>
        </p:nvGrpSpPr>
        <p:grpSpPr>
          <a:xfrm>
            <a:off x="2987487" y="728844"/>
            <a:ext cx="945736" cy="776615"/>
            <a:chOff x="5278399" y="3996"/>
            <a:chExt cx="945736" cy="776615"/>
          </a:xfrm>
        </p:grpSpPr>
        <p:sp>
          <p:nvSpPr>
            <p:cNvPr id="91" name="TextBox 90"/>
            <p:cNvSpPr txBox="1"/>
            <p:nvPr/>
          </p:nvSpPr>
          <p:spPr>
            <a:xfrm>
              <a:off x="5365178" y="534390"/>
              <a:ext cx="7915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LA</a:t>
              </a: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5288417" y="589094"/>
              <a:ext cx="103841" cy="121223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5365180" y="334406"/>
              <a:ext cx="858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HA</a:t>
              </a:r>
            </a:p>
          </p:txBody>
        </p:sp>
        <p:sp>
          <p:nvSpPr>
            <p:cNvPr id="94" name="Rectangle 93"/>
            <p:cNvSpPr/>
            <p:nvPr/>
          </p:nvSpPr>
          <p:spPr>
            <a:xfrm>
              <a:off x="5287224" y="401006"/>
              <a:ext cx="106218" cy="12216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5278399" y="3996"/>
              <a:ext cx="7534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nchorage</a:t>
              </a:r>
            </a:p>
            <a:p>
              <a:pPr algn="ctr"/>
              <a:r>
                <a:rPr lang="en-US" sz="1000" dirty="0"/>
                <a:t>conditions</a:t>
              </a:r>
            </a:p>
          </p:txBody>
        </p:sp>
        <p:cxnSp>
          <p:nvCxnSpPr>
            <p:cNvPr id="96" name="Straight Connector 95"/>
            <p:cNvCxnSpPr/>
            <p:nvPr/>
          </p:nvCxnSpPr>
          <p:spPr>
            <a:xfrm>
              <a:off x="5335484" y="354706"/>
              <a:ext cx="658280" cy="635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9" name="Group 178"/>
          <p:cNvGrpSpPr/>
          <p:nvPr/>
        </p:nvGrpSpPr>
        <p:grpSpPr>
          <a:xfrm>
            <a:off x="1080978" y="1029526"/>
            <a:ext cx="526695" cy="863639"/>
            <a:chOff x="5052767" y="842234"/>
            <a:chExt cx="1189349" cy="1101254"/>
          </a:xfrm>
        </p:grpSpPr>
        <p:cxnSp>
          <p:nvCxnSpPr>
            <p:cNvPr id="180" name="Straight Connector 179"/>
            <p:cNvCxnSpPr/>
            <p:nvPr/>
          </p:nvCxnSpPr>
          <p:spPr>
            <a:xfrm>
              <a:off x="5052767" y="842234"/>
              <a:ext cx="0" cy="266658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/>
            <p:cNvCxnSpPr/>
            <p:nvPr/>
          </p:nvCxnSpPr>
          <p:spPr>
            <a:xfrm>
              <a:off x="6242116" y="842234"/>
              <a:ext cx="0" cy="1101254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Straight Connector 181"/>
            <p:cNvCxnSpPr/>
            <p:nvPr/>
          </p:nvCxnSpPr>
          <p:spPr>
            <a:xfrm flipH="1">
              <a:off x="5052767" y="853355"/>
              <a:ext cx="1189349" cy="1"/>
            </a:xfrm>
            <a:prstGeom prst="line">
              <a:avLst/>
            </a:prstGeom>
            <a:ln w="19050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" name="TextBox 183"/>
          <p:cNvSpPr txBox="1"/>
          <p:nvPr/>
        </p:nvSpPr>
        <p:spPr>
          <a:xfrm>
            <a:off x="1228396" y="801152"/>
            <a:ext cx="280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*</a:t>
            </a:r>
          </a:p>
        </p:txBody>
      </p:sp>
      <p:sp>
        <p:nvSpPr>
          <p:cNvPr id="208" name="TextBox 207"/>
          <p:cNvSpPr txBox="1"/>
          <p:nvPr/>
        </p:nvSpPr>
        <p:spPr>
          <a:xfrm>
            <a:off x="167899" y="3513910"/>
            <a:ext cx="2920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grpSp>
        <p:nvGrpSpPr>
          <p:cNvPr id="172" name="Group 171"/>
          <p:cNvGrpSpPr/>
          <p:nvPr/>
        </p:nvGrpSpPr>
        <p:grpSpPr>
          <a:xfrm>
            <a:off x="3095453" y="3479365"/>
            <a:ext cx="945736" cy="776615"/>
            <a:chOff x="5278399" y="3996"/>
            <a:chExt cx="945736" cy="776615"/>
          </a:xfrm>
        </p:grpSpPr>
        <p:sp>
          <p:nvSpPr>
            <p:cNvPr id="173" name="TextBox 172"/>
            <p:cNvSpPr txBox="1"/>
            <p:nvPr/>
          </p:nvSpPr>
          <p:spPr>
            <a:xfrm>
              <a:off x="5365178" y="534390"/>
              <a:ext cx="7915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LA</a:t>
              </a:r>
            </a:p>
          </p:txBody>
        </p:sp>
        <p:sp>
          <p:nvSpPr>
            <p:cNvPr id="174" name="Rectangle 173"/>
            <p:cNvSpPr/>
            <p:nvPr/>
          </p:nvSpPr>
          <p:spPr>
            <a:xfrm>
              <a:off x="5288417" y="589094"/>
              <a:ext cx="103841" cy="121223"/>
            </a:xfrm>
            <a:prstGeom prst="rect">
              <a:avLst/>
            </a:prstGeom>
            <a:solidFill>
              <a:schemeClr val="tx1"/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tx1"/>
                </a:solidFill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5365180" y="334406"/>
              <a:ext cx="85895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HA</a:t>
              </a:r>
            </a:p>
          </p:txBody>
        </p:sp>
        <p:sp>
          <p:nvSpPr>
            <p:cNvPr id="176" name="Rectangle 175"/>
            <p:cNvSpPr/>
            <p:nvPr/>
          </p:nvSpPr>
          <p:spPr>
            <a:xfrm>
              <a:off x="5287224" y="401006"/>
              <a:ext cx="106218" cy="122169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5278399" y="3996"/>
              <a:ext cx="75346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/>
                <a:t>Anchorage</a:t>
              </a:r>
            </a:p>
            <a:p>
              <a:pPr algn="ctr"/>
              <a:r>
                <a:rPr lang="en-US" sz="1000" dirty="0"/>
                <a:t>conditions</a:t>
              </a:r>
            </a:p>
          </p:txBody>
        </p:sp>
        <p:cxnSp>
          <p:nvCxnSpPr>
            <p:cNvPr id="178" name="Straight Connector 177"/>
            <p:cNvCxnSpPr/>
            <p:nvPr/>
          </p:nvCxnSpPr>
          <p:spPr>
            <a:xfrm>
              <a:off x="5335484" y="354706"/>
              <a:ext cx="658280" cy="6355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9" name="TextBox 208"/>
          <p:cNvSpPr txBox="1"/>
          <p:nvPr/>
        </p:nvSpPr>
        <p:spPr>
          <a:xfrm>
            <a:off x="127818" y="6504573"/>
            <a:ext cx="2712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943430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7</TotalTime>
  <Words>156</Words>
  <Application>Microsoft Macintosh PowerPoint</Application>
  <PresentationFormat>On-screen Show 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ＭＳ Ｐゴシック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8</cp:revision>
  <dcterms:created xsi:type="dcterms:W3CDTF">2016-03-03T15:39:21Z</dcterms:created>
  <dcterms:modified xsi:type="dcterms:W3CDTF">2018-05-09T15:06:05Z</dcterms:modified>
</cp:coreProperties>
</file>